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1764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30/07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30/07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520714"/>
            <a:ext cx="684076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Galindo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244-y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Overview of the advantages and disadvantages of diabetes technology in individuals with diabetes and ESKD</a:t>
            </a:r>
            <a:endParaRPr lang="en-GB" sz="1800" b="1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B858E2E-CC62-9D25-CCAC-66B9EC24D8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06504" y="1092080"/>
            <a:ext cx="4730993" cy="4673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9</cp:revision>
  <dcterms:created xsi:type="dcterms:W3CDTF">2016-06-15T12:53:43Z</dcterms:created>
  <dcterms:modified xsi:type="dcterms:W3CDTF">2024-07-30T10:57:07Z</dcterms:modified>
</cp:coreProperties>
</file>